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6" r:id="rId2"/>
    <p:sldId id="311" r:id="rId3"/>
    <p:sldId id="297" r:id="rId4"/>
  </p:sldIdLst>
  <p:sldSz cx="6858000" cy="9144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515" autoAdjust="0"/>
    <p:restoredTop sz="91892" autoAdjust="0"/>
  </p:normalViewPr>
  <p:slideViewPr>
    <p:cSldViewPr snapToGrid="0">
      <p:cViewPr>
        <p:scale>
          <a:sx n="73" d="100"/>
          <a:sy n="73" d="100"/>
        </p:scale>
        <p:origin x="23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5797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9F04538A-1278-42B2-A580-E653F1183098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7750" y="1160463"/>
            <a:ext cx="2351088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1"/>
            <a:ext cx="5588000" cy="3655457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5796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5796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545F7166-2983-44FE-9488-F09B16964D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499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5F7166-2983-44FE-9488-F09B16964D5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916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C6B5DE-6DFC-4586-94C2-23A7EFAE5E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714914-3EF1-46A6-94B5-BDF50BC76A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73F4A-430E-439D-9C1E-F9A93BB3D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7C7BA8-3F3E-46F6-92D9-333E0A4E9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EA7D21-2164-497A-B962-99C32D344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373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73718-EF08-45B9-9CF1-7D914D57AA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B16702-67B6-41EE-BB53-70C614A4BB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960F3-8F87-4736-8671-84FEE63DF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550C41-56AF-4826-87BF-C5361D88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B49CB0-BEF5-42D5-9525-21E7E37EC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568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9B94BA-EAD5-4115-9F50-CD99ABAFDC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EE60EF-B1F0-4781-B690-6AB494654E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C04FFF-2591-4EF4-8DBE-1B28D61F2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679076-3E2D-48FF-B69D-DA351426C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15AD78-B705-40DF-A5B6-F06746064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155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78E2CC-C438-4BD9-876D-C658475344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4B4238-4E02-4021-9DA3-EDD8A496A7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5724BC-D97F-40F2-835C-8188A58A0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5870ED-2A77-4C88-A354-C7FC9E029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95B052-A183-4072-BF5B-2029AECF0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116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EE7EB-9368-4DC3-9177-E6986EFA1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D007FA-6AD6-4377-968B-D03C06A940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CF4C1-CED3-44FE-BD92-C1DC14531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A15EF1-3E31-4DAA-BD66-53CE41CA5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14194C-6E52-4043-92D0-01B3296BB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402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F360BF-EB46-4CEC-AFCB-8B4115F3BF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0F1AD5-F082-4A4E-9B3B-475A399338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E99044-496D-4880-98F6-0AA22A4C1A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3BD8A3-2A65-4851-82D3-D4DB84F30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31BB04-3103-4784-B861-80FD57814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7D6A87-3500-4263-B3A2-B5E22DC7E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07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E06CB-C7C0-4112-94E0-E36DBD2D1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2A939D-5511-4660-B4EF-DFFB1ECCC0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15513C-57FE-42E7-9450-E7B3239E62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758F77-BB5C-4384-9333-7FCD38E5E6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BA1D2F-F6DC-48F0-8DD8-CD108B1B3F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B2475A-004B-4785-9AA6-3CA01F6B6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AE2124-96D7-4518-850B-12E489999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C7BDFA-0C19-4E17-80AB-2CB94066E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699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CFF25-C303-4ADF-A7B7-2F1B3F899C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01CC9A-6C39-4D64-A7A1-15871E7DC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5EE1F4-A229-4C1F-A4CF-865F965BA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025AE6-6698-4F99-8872-3AC8EAB54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804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7A22DA-1ABA-4065-BC28-5046FA71E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0219B3-40DA-4CB1-926C-4E83C4755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708E06-7CEB-41DC-9243-DDB48E026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777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DFA41-7ABC-4F4D-B2E0-A74E30AFE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9014B1-98F8-47D1-9098-6502E83235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2770CB-2A40-4DAC-97FF-EB1B670F65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FA79C8-3E4C-453D-AF43-8EA343B42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55C8AA-F65E-47AC-8278-1BBDA1A1A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49CE85-9107-46FA-8B27-B7AA1EAF9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31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24A41E-FFD2-4AE1-ACA1-D9DCE8188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4530D2-12E9-4487-BAA2-CE146006B0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CEC421-2FC6-4819-8EBA-0685E14127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240951-F4B3-4614-8FEF-2F8C94BB7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BC8144-6C79-4EF4-A669-EA87186F2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489D26-254F-4626-943F-58D422BE6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94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3A153B-3A7C-49AF-B18A-A2230DF0A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4DC0E0-8FAE-4715-BF87-FC1CBA383E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DC4E6-9382-4D1C-A5A3-5E9D032FE9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1E605-6CE7-49A1-BA9F-D5D86681AB0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E5EB-C1F1-4B59-BE13-8D3063F702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FC2157-3A42-44DD-B25E-C5CBEA862F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6CD14E-D2A2-4CF7-8028-3510BCD57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123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B112884C-C864-47CC-A225-ADA43649B7E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7153"/>
          <a:stretch/>
        </p:blipFill>
        <p:spPr>
          <a:xfrm>
            <a:off x="3261556" y="6773704"/>
            <a:ext cx="3596444" cy="1828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39F8280-11FB-4E4B-8A8E-EB81CA73DA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09"/>
          <a:stretch/>
        </p:blipFill>
        <p:spPr>
          <a:xfrm>
            <a:off x="-2" y="6682264"/>
            <a:ext cx="3346405" cy="20116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210E7A4-3C51-4229-A325-284B676A5B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261" y="369332"/>
            <a:ext cx="5687486" cy="5943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8A356EE-4CFD-4AB2-A6EF-2504B385A41A}"/>
              </a:ext>
            </a:extLst>
          </p:cNvPr>
          <p:cNvSpPr txBox="1"/>
          <p:nvPr/>
        </p:nvSpPr>
        <p:spPr>
          <a:xfrm>
            <a:off x="0" y="0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BB1A4F-90C8-47DC-BB3B-952D79D9CB5B}"/>
              </a:ext>
            </a:extLst>
          </p:cNvPr>
          <p:cNvSpPr txBox="1"/>
          <p:nvPr/>
        </p:nvSpPr>
        <p:spPr>
          <a:xfrm>
            <a:off x="-1" y="30944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7AD53B-26B1-4C23-B66A-BED51414C4AF}"/>
              </a:ext>
            </a:extLst>
          </p:cNvPr>
          <p:cNvSpPr txBox="1"/>
          <p:nvPr/>
        </p:nvSpPr>
        <p:spPr>
          <a:xfrm>
            <a:off x="20035" y="643552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C6D5218-C232-4E1E-88B4-DBF4D0614D9D}"/>
              </a:ext>
            </a:extLst>
          </p:cNvPr>
          <p:cNvSpPr txBox="1"/>
          <p:nvPr/>
        </p:nvSpPr>
        <p:spPr>
          <a:xfrm>
            <a:off x="3346636" y="643552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381468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042A93D0-C3F5-40AA-8D15-E8585ADCBC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2261" y="5226199"/>
            <a:ext cx="1307753" cy="27432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1720AD0C-481D-4E10-8869-721028BA0A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65014" y="5226199"/>
            <a:ext cx="2225351" cy="27432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8B344E0-256A-4775-9208-EB5DD05073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6" y="2957118"/>
            <a:ext cx="4114800" cy="208349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4588952-B009-4EA3-AE0C-B050886ED4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" y="566713"/>
            <a:ext cx="3969327" cy="2286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145BC6F-D862-4409-9A66-F06AA4C99D21}"/>
              </a:ext>
            </a:extLst>
          </p:cNvPr>
          <p:cNvSpPr txBox="1"/>
          <p:nvPr/>
        </p:nvSpPr>
        <p:spPr>
          <a:xfrm>
            <a:off x="0" y="4479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47F53CC-045F-4123-A4C0-F2E9657690FB}"/>
              </a:ext>
            </a:extLst>
          </p:cNvPr>
          <p:cNvSpPr txBox="1"/>
          <p:nvPr/>
        </p:nvSpPr>
        <p:spPr>
          <a:xfrm>
            <a:off x="-27366" y="327126"/>
            <a:ext cx="326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4F2B13-7D27-4BDB-A734-9B68106B36C7}"/>
              </a:ext>
            </a:extLst>
          </p:cNvPr>
          <p:cNvSpPr txBox="1"/>
          <p:nvPr/>
        </p:nvSpPr>
        <p:spPr>
          <a:xfrm>
            <a:off x="1462799" y="32712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B15620-9D27-4FAE-9DCA-D4CEDA6FD44B}"/>
              </a:ext>
            </a:extLst>
          </p:cNvPr>
          <p:cNvSpPr txBox="1"/>
          <p:nvPr/>
        </p:nvSpPr>
        <p:spPr>
          <a:xfrm>
            <a:off x="-1313" y="28004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8124BE16-DDDD-49A6-AF1A-474FC8BA665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5202939"/>
            <a:ext cx="2483179" cy="246888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9353244B-44D6-4D2D-8A33-8BA394EA0902}"/>
              </a:ext>
            </a:extLst>
          </p:cNvPr>
          <p:cNvSpPr txBox="1"/>
          <p:nvPr/>
        </p:nvSpPr>
        <p:spPr>
          <a:xfrm>
            <a:off x="4022859" y="5018273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7E4771-774B-43ED-9BC1-52AC59E5C1E3}"/>
              </a:ext>
            </a:extLst>
          </p:cNvPr>
          <p:cNvSpPr txBox="1"/>
          <p:nvPr/>
        </p:nvSpPr>
        <p:spPr>
          <a:xfrm>
            <a:off x="-14137" y="501827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8BCFF4-9854-41A2-B6B4-F8AD636B85EA}"/>
              </a:ext>
            </a:extLst>
          </p:cNvPr>
          <p:cNvSpPr txBox="1"/>
          <p:nvPr/>
        </p:nvSpPr>
        <p:spPr>
          <a:xfrm>
            <a:off x="2550626" y="501827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5450571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40A2C95A-90D7-4D40-8BFB-2BB4137F7B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20" y="3313639"/>
            <a:ext cx="4204741" cy="27432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2AAB6A5-0639-4E7C-B7E2-9B981036BC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52" y="594162"/>
            <a:ext cx="6075153" cy="27432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145BC6F-D862-4409-9A66-F06AA4C99D21}"/>
              </a:ext>
            </a:extLst>
          </p:cNvPr>
          <p:cNvSpPr txBox="1"/>
          <p:nvPr/>
        </p:nvSpPr>
        <p:spPr>
          <a:xfrm>
            <a:off x="0" y="4479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47F53CC-045F-4123-A4C0-F2E9657690FB}"/>
              </a:ext>
            </a:extLst>
          </p:cNvPr>
          <p:cNvSpPr txBox="1"/>
          <p:nvPr/>
        </p:nvSpPr>
        <p:spPr>
          <a:xfrm>
            <a:off x="37227" y="439786"/>
            <a:ext cx="326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4F2B13-7D27-4BDB-A734-9B68106B36C7}"/>
              </a:ext>
            </a:extLst>
          </p:cNvPr>
          <p:cNvSpPr txBox="1"/>
          <p:nvPr/>
        </p:nvSpPr>
        <p:spPr>
          <a:xfrm>
            <a:off x="3128169" y="43978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B15620-9D27-4FAE-9DCA-D4CEDA6FD44B}"/>
              </a:ext>
            </a:extLst>
          </p:cNvPr>
          <p:cNvSpPr txBox="1"/>
          <p:nvPr/>
        </p:nvSpPr>
        <p:spPr>
          <a:xfrm>
            <a:off x="4652350" y="43978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7E4771-774B-43ED-9BC1-52AC59E5C1E3}"/>
              </a:ext>
            </a:extLst>
          </p:cNvPr>
          <p:cNvSpPr txBox="1"/>
          <p:nvPr/>
        </p:nvSpPr>
        <p:spPr>
          <a:xfrm>
            <a:off x="37227" y="316269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057542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11</TotalTime>
  <Words>23</Words>
  <Application>Microsoft Office PowerPoint</Application>
  <PresentationFormat>On-screen Show (4:3)</PresentationFormat>
  <Paragraphs>1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ko, Justin</dc:creator>
  <cp:lastModifiedBy>Zimmerman, Jennifer</cp:lastModifiedBy>
  <cp:revision>371</cp:revision>
  <cp:lastPrinted>2019-09-26T16:50:11Z</cp:lastPrinted>
  <dcterms:created xsi:type="dcterms:W3CDTF">2019-03-06T17:26:33Z</dcterms:created>
  <dcterms:modified xsi:type="dcterms:W3CDTF">2022-04-20T21:19:13Z</dcterms:modified>
</cp:coreProperties>
</file>